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4"/>
  </p:notesMasterIdLst>
  <p:sldIdLst>
    <p:sldId id="257" r:id="rId5"/>
    <p:sldId id="685" r:id="rId6"/>
    <p:sldId id="695" r:id="rId7"/>
    <p:sldId id="696" r:id="rId8"/>
    <p:sldId id="699" r:id="rId9"/>
    <p:sldId id="700" r:id="rId10"/>
    <p:sldId id="701" r:id="rId11"/>
    <p:sldId id="702" r:id="rId12"/>
    <p:sldId id="70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306BF84-6BE3-4EB8-C0A4-94B9996BC477}" v="10" dt="2026-03-13T21:52:45.7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86" d="100"/>
          <a:sy n="86" d="100"/>
        </p:scale>
        <p:origin x="96" y="8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nner, Scott E." userId="S::penner.scott@mayo.edu::38196f4f-174b-49ce-a920-45d894189adf" providerId="AD" clId="Web-{8306BF84-6BE3-4EB8-C0A4-94B9996BC477}"/>
    <pc:docChg chg="addSld delSld">
      <pc:chgData name="Penner, Scott E." userId="S::penner.scott@mayo.edu::38196f4f-174b-49ce-a920-45d894189adf" providerId="AD" clId="Web-{8306BF84-6BE3-4EB8-C0A4-94B9996BC477}" dt="2026-03-13T21:52:45.783" v="9"/>
      <pc:docMkLst>
        <pc:docMk/>
      </pc:docMkLst>
      <pc:sldChg chg="del">
        <pc:chgData name="Penner, Scott E." userId="S::penner.scott@mayo.edu::38196f4f-174b-49ce-a920-45d894189adf" providerId="AD" clId="Web-{8306BF84-6BE3-4EB8-C0A4-94B9996BC477}" dt="2026-03-13T21:52:22.237" v="0"/>
        <pc:sldMkLst>
          <pc:docMk/>
          <pc:sldMk cId="109857222" sldId="256"/>
        </pc:sldMkLst>
      </pc:sldChg>
      <pc:sldChg chg="add">
        <pc:chgData name="Penner, Scott E." userId="S::penner.scott@mayo.edu::38196f4f-174b-49ce-a920-45d894189adf" providerId="AD" clId="Web-{8306BF84-6BE3-4EB8-C0A4-94B9996BC477}" dt="2026-03-13T21:52:44.455" v="1"/>
        <pc:sldMkLst>
          <pc:docMk/>
          <pc:sldMk cId="3277466295" sldId="257"/>
        </pc:sldMkLst>
      </pc:sldChg>
      <pc:sldChg chg="add">
        <pc:chgData name="Penner, Scott E." userId="S::penner.scott@mayo.edu::38196f4f-174b-49ce-a920-45d894189adf" providerId="AD" clId="Web-{8306BF84-6BE3-4EB8-C0A4-94B9996BC477}" dt="2026-03-13T21:52:44.737" v="2"/>
        <pc:sldMkLst>
          <pc:docMk/>
          <pc:sldMk cId="3265989222" sldId="685"/>
        </pc:sldMkLst>
      </pc:sldChg>
      <pc:sldChg chg="add">
        <pc:chgData name="Penner, Scott E." userId="S::penner.scott@mayo.edu::38196f4f-174b-49ce-a920-45d894189adf" providerId="AD" clId="Web-{8306BF84-6BE3-4EB8-C0A4-94B9996BC477}" dt="2026-03-13T21:52:44.815" v="3"/>
        <pc:sldMkLst>
          <pc:docMk/>
          <pc:sldMk cId="3685252158" sldId="695"/>
        </pc:sldMkLst>
      </pc:sldChg>
      <pc:sldChg chg="add">
        <pc:chgData name="Penner, Scott E." userId="S::penner.scott@mayo.edu::38196f4f-174b-49ce-a920-45d894189adf" providerId="AD" clId="Web-{8306BF84-6BE3-4EB8-C0A4-94B9996BC477}" dt="2026-03-13T21:52:44.893" v="4"/>
        <pc:sldMkLst>
          <pc:docMk/>
          <pc:sldMk cId="1184328320" sldId="696"/>
        </pc:sldMkLst>
      </pc:sldChg>
      <pc:sldChg chg="add">
        <pc:chgData name="Penner, Scott E." userId="S::penner.scott@mayo.edu::38196f4f-174b-49ce-a920-45d894189adf" providerId="AD" clId="Web-{8306BF84-6BE3-4EB8-C0A4-94B9996BC477}" dt="2026-03-13T21:52:45.096" v="5"/>
        <pc:sldMkLst>
          <pc:docMk/>
          <pc:sldMk cId="1686085538" sldId="699"/>
        </pc:sldMkLst>
      </pc:sldChg>
      <pc:sldChg chg="add">
        <pc:chgData name="Penner, Scott E." userId="S::penner.scott@mayo.edu::38196f4f-174b-49ce-a920-45d894189adf" providerId="AD" clId="Web-{8306BF84-6BE3-4EB8-C0A4-94B9996BC477}" dt="2026-03-13T21:52:45.283" v="6"/>
        <pc:sldMkLst>
          <pc:docMk/>
          <pc:sldMk cId="521173280" sldId="700"/>
        </pc:sldMkLst>
      </pc:sldChg>
      <pc:sldChg chg="add">
        <pc:chgData name="Penner, Scott E." userId="S::penner.scott@mayo.edu::38196f4f-174b-49ce-a920-45d894189adf" providerId="AD" clId="Web-{8306BF84-6BE3-4EB8-C0A4-94B9996BC477}" dt="2026-03-13T21:52:45.486" v="7"/>
        <pc:sldMkLst>
          <pc:docMk/>
          <pc:sldMk cId="2768633051" sldId="701"/>
        </pc:sldMkLst>
      </pc:sldChg>
      <pc:sldChg chg="add">
        <pc:chgData name="Penner, Scott E." userId="S::penner.scott@mayo.edu::38196f4f-174b-49ce-a920-45d894189adf" providerId="AD" clId="Web-{8306BF84-6BE3-4EB8-C0A4-94B9996BC477}" dt="2026-03-13T21:52:45.580" v="8"/>
        <pc:sldMkLst>
          <pc:docMk/>
          <pc:sldMk cId="1459521911" sldId="702"/>
        </pc:sldMkLst>
      </pc:sldChg>
      <pc:sldChg chg="add">
        <pc:chgData name="Penner, Scott E." userId="S::penner.scott@mayo.edu::38196f4f-174b-49ce-a920-45d894189adf" providerId="AD" clId="Web-{8306BF84-6BE3-4EB8-C0A4-94B9996BC477}" dt="2026-03-13T21:52:45.783" v="9"/>
        <pc:sldMkLst>
          <pc:docMk/>
          <pc:sldMk cId="1924948352" sldId="70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D59902-88D2-4BE5-9F4B-30685069CA54}" type="datetimeFigureOut">
              <a:t>3/13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85EBE3-6365-413C-BD84-4B5EEF246D10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136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42130DB-5A34-4451-87C8-943CBB0380D9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05191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342900"/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42130DB-5A34-4451-87C8-943CBB0380D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06663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8A65A8-2190-AC45-838C-33627E37840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171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>
              <a:latin typeface="Calibri"/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8A65A8-2190-AC45-838C-33627E37840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37515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8A65A8-2190-AC45-838C-33627E37840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26823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8A65A8-2190-AC45-838C-33627E378408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168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7B9649E-61E1-C51C-B95D-4051BF7476FA}"/>
              </a:ext>
            </a:extLst>
          </p:cNvPr>
          <p:cNvSpPr txBox="1"/>
          <p:nvPr/>
        </p:nvSpPr>
        <p:spPr>
          <a:xfrm>
            <a:off x="5073702" y="463157"/>
            <a:ext cx="1956305" cy="223138"/>
          </a:xfrm>
          <a:prstGeom prst="rect">
            <a:avLst/>
          </a:prstGeom>
          <a:noFill/>
        </p:spPr>
        <p:txBody>
          <a:bodyPr wrap="none" lIns="68580" tIns="34290" rIns="68580" bIns="34290" rtlCol="0" anchor="t">
            <a:spAutoFit/>
          </a:bodyPr>
          <a:lstStyle/>
          <a:p>
            <a:pPr defTabSz="342900"/>
            <a:r>
              <a:rPr lang="en-US" sz="1000" b="1">
                <a:solidFill>
                  <a:prstClr val="black"/>
                </a:solidFill>
                <a:latin typeface="Aptos" panose="02110004020202020204"/>
              </a:rPr>
              <a:t>Figure S1: Secondary Measures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5494C4C9-4C03-0069-DA8D-C272FF57B35C}"/>
              </a:ext>
            </a:extLst>
          </p:cNvPr>
          <p:cNvGrpSpPr/>
          <p:nvPr/>
        </p:nvGrpSpPr>
        <p:grpSpPr>
          <a:xfrm>
            <a:off x="3586588" y="1017309"/>
            <a:ext cx="5018823" cy="4298802"/>
            <a:chOff x="157471" y="494467"/>
            <a:chExt cx="8441255" cy="832119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CBBD948-A2D6-ABA5-47ED-B49825ECC5C2}"/>
                </a:ext>
              </a:extLst>
            </p:cNvPr>
            <p:cNvGrpSpPr/>
            <p:nvPr/>
          </p:nvGrpSpPr>
          <p:grpSpPr>
            <a:xfrm>
              <a:off x="217375" y="494467"/>
              <a:ext cx="8381351" cy="4121942"/>
              <a:chOff x="478632" y="1466017"/>
              <a:chExt cx="8381351" cy="4121942"/>
            </a:xfrm>
          </p:grpSpPr>
          <p:pic>
            <p:nvPicPr>
              <p:cNvPr id="2" name="Picture 1" descr="A graph of different colored lines&#10;&#10;AI-generated content may be incorrect.">
                <a:extLst>
                  <a:ext uri="{FF2B5EF4-FFF2-40B4-BE49-F238E27FC236}">
                    <a16:creationId xmlns:a16="http://schemas.microsoft.com/office/drawing/2014/main" id="{07105572-5EC0-D3F8-0C7E-91B4976454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t="7246"/>
              <a:stretch/>
            </p:blipFill>
            <p:spPr>
              <a:xfrm>
                <a:off x="478632" y="1673767"/>
                <a:ext cx="8381351" cy="3914192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E0729C30-6300-D0B4-1FD6-637DB4C76BCD}"/>
                  </a:ext>
                </a:extLst>
              </p:cNvPr>
              <p:cNvSpPr txBox="1"/>
              <p:nvPr/>
            </p:nvSpPr>
            <p:spPr>
              <a:xfrm>
                <a:off x="721054" y="1466019"/>
                <a:ext cx="2737756" cy="301607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51435" tIns="25718" rIns="51435" bIns="25718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marL="192885" indent="-192885" defTabSz="342900">
                  <a:buFontTx/>
                  <a:buAutoNum type="alphaUcPeriod"/>
                </a:pPr>
                <a:r>
                  <a:rPr lang="en-US" sz="675">
                    <a:solidFill>
                      <a:prstClr val="black"/>
                    </a:solidFill>
                    <a:latin typeface="Aptos" panose="02110004020202020204"/>
                  </a:rPr>
                  <a:t>LPPAI score by time points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FDFDF9A1-020F-0D96-F0AF-C705CF9081C0}"/>
                  </a:ext>
                </a:extLst>
              </p:cNvPr>
              <p:cNvSpPr txBox="1"/>
              <p:nvPr/>
            </p:nvSpPr>
            <p:spPr>
              <a:xfrm>
                <a:off x="4841404" y="1466017"/>
                <a:ext cx="2737756" cy="301607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51435" tIns="25718" rIns="51435" bIns="25718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defTabSz="342900"/>
                <a:r>
                  <a:rPr lang="en-US" sz="675">
                    <a:solidFill>
                      <a:prstClr val="black"/>
                    </a:solidFill>
                    <a:latin typeface="Aptos" panose="02110004020202020204"/>
                  </a:rPr>
                  <a:t>B.  Pruritus NRS by time points</a:t>
                </a:r>
                <a:endParaRPr lang="en-US" sz="1013">
                  <a:solidFill>
                    <a:prstClr val="black"/>
                  </a:solidFill>
                  <a:latin typeface="Aptos" panose="02110004020202020204"/>
                </a:endParaRP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BC6DED98-8707-FE6C-F230-CF09B7DED74B}"/>
                </a:ext>
              </a:extLst>
            </p:cNvPr>
            <p:cNvGrpSpPr/>
            <p:nvPr/>
          </p:nvGrpSpPr>
          <p:grpSpPr>
            <a:xfrm>
              <a:off x="157471" y="4616408"/>
              <a:ext cx="8441255" cy="4199255"/>
              <a:chOff x="392620" y="1417032"/>
              <a:chExt cx="8441255" cy="4199255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370A99F6-A08E-52D1-B48F-C1E983FA5C35}"/>
                  </a:ext>
                </a:extLst>
              </p:cNvPr>
              <p:cNvSpPr txBox="1"/>
              <p:nvPr/>
            </p:nvSpPr>
            <p:spPr>
              <a:xfrm>
                <a:off x="721053" y="1466019"/>
                <a:ext cx="2737758" cy="301607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51435" tIns="25718" rIns="51435" bIns="25718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defTabSz="342900"/>
                <a:r>
                  <a:rPr lang="en-US" sz="675">
                    <a:solidFill>
                      <a:prstClr val="black"/>
                    </a:solidFill>
                    <a:latin typeface="Aptos" panose="02110004020202020204"/>
                  </a:rPr>
                  <a:t>C.       Skindex-16 score by time points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16761D9-6422-703D-DF52-7F95288A80E3}"/>
                  </a:ext>
                </a:extLst>
              </p:cNvPr>
              <p:cNvSpPr txBox="1"/>
              <p:nvPr/>
            </p:nvSpPr>
            <p:spPr>
              <a:xfrm>
                <a:off x="4815296" y="1417032"/>
                <a:ext cx="2737758" cy="301607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51435" tIns="25718" rIns="51435" bIns="25718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defTabSz="342900"/>
                <a:r>
                  <a:rPr lang="en-US" sz="675">
                    <a:solidFill>
                      <a:prstClr val="black"/>
                    </a:solidFill>
                    <a:latin typeface="Aptos" panose="02110004020202020204"/>
                  </a:rPr>
                  <a:t>D.  DLQI score by time points</a:t>
                </a:r>
                <a:endParaRPr lang="en-US" sz="1013">
                  <a:solidFill>
                    <a:prstClr val="black"/>
                  </a:solidFill>
                  <a:latin typeface="Aptos" panose="02110004020202020204"/>
                </a:endParaRPr>
              </a:p>
            </p:txBody>
          </p:sp>
          <p:pic>
            <p:nvPicPr>
              <p:cNvPr id="10" name="Picture 9" descr="A graph of different colored lines&#10;&#10;AI-generated content may be incorrect.">
                <a:extLst>
                  <a:ext uri="{FF2B5EF4-FFF2-40B4-BE49-F238E27FC236}">
                    <a16:creationId xmlns:a16="http://schemas.microsoft.com/office/drawing/2014/main" id="{269E257C-CF42-75F7-412B-4685860000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774"/>
              <a:stretch/>
            </p:blipFill>
            <p:spPr>
              <a:xfrm>
                <a:off x="392620" y="1673766"/>
                <a:ext cx="8441255" cy="3942521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277466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A6D63A3C-D469-0EC4-04D3-B4A077CBF2A0}"/>
              </a:ext>
            </a:extLst>
          </p:cNvPr>
          <p:cNvGrpSpPr/>
          <p:nvPr/>
        </p:nvGrpSpPr>
        <p:grpSpPr>
          <a:xfrm>
            <a:off x="3774980" y="1073691"/>
            <a:ext cx="1807653" cy="5440428"/>
            <a:chOff x="4879176" y="0"/>
            <a:chExt cx="2410204" cy="7253903"/>
          </a:xfrm>
        </p:grpSpPr>
        <p:pic>
          <p:nvPicPr>
            <p:cNvPr id="4" name="Picture 3" descr="A screen shot of a cell phone&#10;&#10;AI-generated content may be incorrect.">
              <a:extLst>
                <a:ext uri="{FF2B5EF4-FFF2-40B4-BE49-F238E27FC236}">
                  <a16:creationId xmlns:a16="http://schemas.microsoft.com/office/drawing/2014/main" id="{B91C999E-D280-D447-C739-42DB269CFD0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02620" y="0"/>
              <a:ext cx="2386760" cy="6858000"/>
            </a:xfrm>
            <a:prstGeom prst="rect">
              <a:avLst/>
            </a:prstGeom>
          </p:spPr>
        </p:pic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CFE3BB11-2607-DED5-D847-ECAF8875F108}"/>
                </a:ext>
              </a:extLst>
            </p:cNvPr>
            <p:cNvCxnSpPr>
              <a:cxnSpLocks/>
            </p:cNvCxnSpPr>
            <p:nvPr/>
          </p:nvCxnSpPr>
          <p:spPr>
            <a:xfrm>
              <a:off x="5339631" y="0"/>
              <a:ext cx="0" cy="721009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65EB289D-CA1C-3892-8F0E-34AC86904B98}"/>
                </a:ext>
              </a:extLst>
            </p:cNvPr>
            <p:cNvCxnSpPr>
              <a:cxnSpLocks/>
            </p:cNvCxnSpPr>
            <p:nvPr/>
          </p:nvCxnSpPr>
          <p:spPr>
            <a:xfrm>
              <a:off x="5954113" y="0"/>
              <a:ext cx="0" cy="721009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4ED5981-003D-59B5-99BA-0C872FC2A7C9}"/>
                </a:ext>
              </a:extLst>
            </p:cNvPr>
            <p:cNvSpPr txBox="1"/>
            <p:nvPr/>
          </p:nvSpPr>
          <p:spPr>
            <a:xfrm>
              <a:off x="4879176" y="6884570"/>
              <a:ext cx="5753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Ctrl</a:t>
              </a:r>
              <a:endParaRPr lang="en-US" sz="135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7F07E8F-60F0-7CDC-9609-9CD979C5D61E}"/>
                </a:ext>
              </a:extLst>
            </p:cNvPr>
            <p:cNvSpPr txBox="1"/>
            <p:nvPr/>
          </p:nvSpPr>
          <p:spPr>
            <a:xfrm>
              <a:off x="5462615" y="6884571"/>
              <a:ext cx="536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Pre</a:t>
              </a:r>
              <a:endParaRPr lang="en-US" sz="135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80C37CA-7930-792F-FD9C-37BB5C702E27}"/>
                </a:ext>
              </a:extLst>
            </p:cNvPr>
            <p:cNvSpPr txBox="1"/>
            <p:nvPr/>
          </p:nvSpPr>
          <p:spPr>
            <a:xfrm>
              <a:off x="6005979" y="6884571"/>
              <a:ext cx="6348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Post</a:t>
              </a:r>
              <a:endParaRPr lang="en-US" sz="1350"/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6D21A8D4-E695-9A76-ED44-9F0A503AF632}"/>
                </a:ext>
              </a:extLst>
            </p:cNvPr>
            <p:cNvCxnSpPr>
              <a:cxnSpLocks/>
            </p:cNvCxnSpPr>
            <p:nvPr/>
          </p:nvCxnSpPr>
          <p:spPr>
            <a:xfrm>
              <a:off x="4879176" y="3951514"/>
              <a:ext cx="23072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9FAC1A37-AC74-7EDD-3C3C-41A13F3D51BE}"/>
              </a:ext>
            </a:extLst>
          </p:cNvPr>
          <p:cNvGrpSpPr/>
          <p:nvPr/>
        </p:nvGrpSpPr>
        <p:grpSpPr>
          <a:xfrm>
            <a:off x="6224210" y="1292469"/>
            <a:ext cx="2420874" cy="4889585"/>
            <a:chOff x="4241535" y="286059"/>
            <a:chExt cx="3227832" cy="6519446"/>
          </a:xfrm>
        </p:grpSpPr>
        <p:pic>
          <p:nvPicPr>
            <p:cNvPr id="13" name="Picture 12" descr="A screenshot of a computer screen&#10;&#10;AI-generated content may be incorrect.">
              <a:extLst>
                <a:ext uri="{FF2B5EF4-FFF2-40B4-BE49-F238E27FC236}">
                  <a16:creationId xmlns:a16="http://schemas.microsoft.com/office/drawing/2014/main" id="{CBBF2888-D29D-2540-AA04-D04FCAEA02A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26383" t="36086" r="32008" b="21747"/>
            <a:stretch>
              <a:fillRect/>
            </a:stretch>
          </p:blipFill>
          <p:spPr>
            <a:xfrm>
              <a:off x="4241535" y="3605918"/>
              <a:ext cx="3227832" cy="3199587"/>
            </a:xfrm>
            <a:prstGeom prst="rect">
              <a:avLst/>
            </a:prstGeom>
          </p:spPr>
        </p:pic>
        <p:pic>
          <p:nvPicPr>
            <p:cNvPr id="15" name="Picture 14" descr="A group of colorful circles with white text&#10;&#10;AI-generated content may be incorrect.">
              <a:extLst>
                <a:ext uri="{FF2B5EF4-FFF2-40B4-BE49-F238E27FC236}">
                  <a16:creationId xmlns:a16="http://schemas.microsoft.com/office/drawing/2014/main" id="{958E0064-C962-22E2-8095-26853BBE124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23872" t="23721" r="39750" b="35106"/>
            <a:stretch>
              <a:fillRect/>
            </a:stretch>
          </p:blipFill>
          <p:spPr>
            <a:xfrm>
              <a:off x="4241535" y="286059"/>
              <a:ext cx="3108960" cy="2998885"/>
            </a:xfrm>
            <a:prstGeom prst="rect">
              <a:avLst/>
            </a:prstGeom>
          </p:spPr>
        </p:pic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D13AD31F-8417-1541-AAF1-234BFF09CC5D}"/>
              </a:ext>
            </a:extLst>
          </p:cNvPr>
          <p:cNvSpPr txBox="1"/>
          <p:nvPr/>
        </p:nvSpPr>
        <p:spPr>
          <a:xfrm>
            <a:off x="6154029" y="854612"/>
            <a:ext cx="287258" cy="30008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35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F9CD8E7-EA39-D0EC-1538-0125856D206B}"/>
              </a:ext>
            </a:extLst>
          </p:cNvPr>
          <p:cNvSpPr txBox="1"/>
          <p:nvPr/>
        </p:nvSpPr>
        <p:spPr>
          <a:xfrm>
            <a:off x="6166647" y="3687816"/>
            <a:ext cx="288862" cy="30008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350"/>
              <a:t>B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6703E2F-9044-6237-D281-4548D8EF3D88}"/>
              </a:ext>
            </a:extLst>
          </p:cNvPr>
          <p:cNvGrpSpPr/>
          <p:nvPr/>
        </p:nvGrpSpPr>
        <p:grpSpPr>
          <a:xfrm>
            <a:off x="5648816" y="4092502"/>
            <a:ext cx="575394" cy="2105636"/>
            <a:chOff x="2832755" y="5456670"/>
            <a:chExt cx="767192" cy="2807514"/>
          </a:xfrm>
        </p:grpSpPr>
        <p:sp>
          <p:nvSpPr>
            <p:cNvPr id="16" name="Right Brace 15">
              <a:extLst>
                <a:ext uri="{FF2B5EF4-FFF2-40B4-BE49-F238E27FC236}">
                  <a16:creationId xmlns:a16="http://schemas.microsoft.com/office/drawing/2014/main" id="{15385DEC-0B32-76D2-42B2-106752A05E04}"/>
                </a:ext>
              </a:extLst>
            </p:cNvPr>
            <p:cNvSpPr/>
            <p:nvPr/>
          </p:nvSpPr>
          <p:spPr>
            <a:xfrm>
              <a:off x="2832755" y="5456670"/>
              <a:ext cx="331372" cy="2807514"/>
            </a:xfrm>
            <a:prstGeom prst="rightBrace">
              <a:avLst>
                <a:gd name="adj1" fmla="val 81151"/>
                <a:gd name="adj2" fmla="val 50000"/>
              </a:avLst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DF00100B-B71C-0DA2-82B5-015213A76832}"/>
                </a:ext>
              </a:extLst>
            </p:cNvPr>
            <p:cNvCxnSpPr>
              <a:cxnSpLocks/>
            </p:cNvCxnSpPr>
            <p:nvPr/>
          </p:nvCxnSpPr>
          <p:spPr>
            <a:xfrm>
              <a:off x="3152404" y="6860427"/>
              <a:ext cx="44754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6744CFC2-D096-756F-8A4B-E02F19478B10}"/>
              </a:ext>
            </a:extLst>
          </p:cNvPr>
          <p:cNvGrpSpPr/>
          <p:nvPr/>
        </p:nvGrpSpPr>
        <p:grpSpPr>
          <a:xfrm>
            <a:off x="5631080" y="1447904"/>
            <a:ext cx="584186" cy="2578037"/>
            <a:chOff x="2809106" y="1930539"/>
            <a:chExt cx="778915" cy="3437382"/>
          </a:xfrm>
        </p:grpSpPr>
        <p:sp>
          <p:nvSpPr>
            <p:cNvPr id="2" name="Right Brace 1">
              <a:extLst>
                <a:ext uri="{FF2B5EF4-FFF2-40B4-BE49-F238E27FC236}">
                  <a16:creationId xmlns:a16="http://schemas.microsoft.com/office/drawing/2014/main" id="{ED340701-5C9D-D08B-BAE4-F058034C8F93}"/>
                </a:ext>
              </a:extLst>
            </p:cNvPr>
            <p:cNvSpPr/>
            <p:nvPr/>
          </p:nvSpPr>
          <p:spPr>
            <a:xfrm>
              <a:off x="2809106" y="1930539"/>
              <a:ext cx="331372" cy="3437382"/>
            </a:xfrm>
            <a:prstGeom prst="rightBrace">
              <a:avLst>
                <a:gd name="adj1" fmla="val 81151"/>
                <a:gd name="adj2" fmla="val 50000"/>
              </a:avLst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A52884A2-D7B0-0CBC-5058-6519A6311BC6}"/>
                </a:ext>
              </a:extLst>
            </p:cNvPr>
            <p:cNvCxnSpPr>
              <a:cxnSpLocks/>
            </p:cNvCxnSpPr>
            <p:nvPr/>
          </p:nvCxnSpPr>
          <p:spPr>
            <a:xfrm>
              <a:off x="3140478" y="3649230"/>
              <a:ext cx="447543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DE2E2701-818F-25C0-F496-CD28C61B3CE2}"/>
              </a:ext>
            </a:extLst>
          </p:cNvPr>
          <p:cNvSpPr txBox="1"/>
          <p:nvPr/>
        </p:nvSpPr>
        <p:spPr>
          <a:xfrm>
            <a:off x="3524251" y="15482"/>
            <a:ext cx="4407297" cy="223138"/>
          </a:xfrm>
          <a:prstGeom prst="rect">
            <a:avLst/>
          </a:prstGeom>
          <a:noFill/>
        </p:spPr>
        <p:txBody>
          <a:bodyPr wrap="none" lIns="68580" tIns="34290" rIns="68580" bIns="34290" rtlCol="0" anchor="t">
            <a:spAutoFit/>
          </a:bodyPr>
          <a:lstStyle/>
          <a:p>
            <a:pPr defTabSz="342900"/>
            <a:r>
              <a:rPr lang="en-US" sz="1000" b="1">
                <a:solidFill>
                  <a:prstClr val="black"/>
                </a:solidFill>
                <a:latin typeface="Aptos" panose="02110004020202020204"/>
              </a:rPr>
              <a:t>Figure S2: Disease Gene Expression Profiles are Reversed After Treatment</a:t>
            </a:r>
          </a:p>
        </p:txBody>
      </p:sp>
    </p:spTree>
    <p:extLst>
      <p:ext uri="{BB962C8B-B14F-4D97-AF65-F5344CB8AC3E}">
        <p14:creationId xmlns:p14="http://schemas.microsoft.com/office/powerpoint/2010/main" val="3265989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E0A903E-F086-1AC4-938A-57A6E9F16B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4395" y="80922"/>
            <a:ext cx="5232344" cy="202550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13619EB-A868-E9F7-A4D6-1DE3A93270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1887" y="2237051"/>
            <a:ext cx="5232345" cy="229379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CDC001A-89B0-2AD7-A07F-6A66342EA0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54395" y="4523802"/>
            <a:ext cx="5232344" cy="231616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8BB278F-DE21-BBFF-12BB-6F73E889E649}"/>
              </a:ext>
            </a:extLst>
          </p:cNvPr>
          <p:cNvSpPr txBox="1"/>
          <p:nvPr/>
        </p:nvSpPr>
        <p:spPr>
          <a:xfrm>
            <a:off x="3209026" y="207034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E9C7741-9369-87A3-520C-CDAC4AEA96FD}"/>
              </a:ext>
            </a:extLst>
          </p:cNvPr>
          <p:cNvSpPr txBox="1"/>
          <p:nvPr/>
        </p:nvSpPr>
        <p:spPr>
          <a:xfrm>
            <a:off x="3209026" y="239814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F876ED-275F-67D3-DDF8-6A837966AB38}"/>
              </a:ext>
            </a:extLst>
          </p:cNvPr>
          <p:cNvSpPr txBox="1"/>
          <p:nvPr/>
        </p:nvSpPr>
        <p:spPr>
          <a:xfrm>
            <a:off x="3209026" y="4727275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CBAACD9-5CA4-7369-483D-53F378DB0E4B}"/>
              </a:ext>
            </a:extLst>
          </p:cNvPr>
          <p:cNvSpPr txBox="1"/>
          <p:nvPr/>
        </p:nvSpPr>
        <p:spPr>
          <a:xfrm>
            <a:off x="0" y="54194"/>
            <a:ext cx="3312445" cy="223138"/>
          </a:xfrm>
          <a:prstGeom prst="rect">
            <a:avLst/>
          </a:prstGeom>
          <a:noFill/>
        </p:spPr>
        <p:txBody>
          <a:bodyPr wrap="none" lIns="68580" tIns="34290" rIns="68580" bIns="34290" rtlCol="0" anchor="t">
            <a:spAutoFit/>
          </a:bodyPr>
          <a:lstStyle/>
          <a:p>
            <a:pPr defTabSz="342900"/>
            <a:r>
              <a:rPr lang="en-US" sz="1000" b="1">
                <a:solidFill>
                  <a:prstClr val="black"/>
                </a:solidFill>
                <a:latin typeface="Aptos" panose="020B0004020202020204" pitchFamily="34" charset="0"/>
              </a:rPr>
              <a:t>Figure S3: T-cell Expression of Key Cytotoxic Mediators</a:t>
            </a:r>
          </a:p>
        </p:txBody>
      </p:sp>
    </p:spTree>
    <p:extLst>
      <p:ext uri="{BB962C8B-B14F-4D97-AF65-F5344CB8AC3E}">
        <p14:creationId xmlns:p14="http://schemas.microsoft.com/office/powerpoint/2010/main" val="36852521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BC71EF5-0D3C-3A63-8D32-016732CFA3F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760417" y="751436"/>
            <a:ext cx="4994764" cy="297106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ADE4BE1-8ECE-AEFF-F879-20BDD9880BF6}"/>
              </a:ext>
            </a:extLst>
          </p:cNvPr>
          <p:cNvSpPr txBox="1"/>
          <p:nvPr/>
        </p:nvSpPr>
        <p:spPr>
          <a:xfrm>
            <a:off x="2311884" y="753299"/>
            <a:ext cx="260385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defTabSz="342900"/>
            <a:r>
              <a:rPr lang="en-US" sz="1350">
                <a:solidFill>
                  <a:prstClr val="black"/>
                </a:solidFill>
                <a:latin typeface="Aptos" panose="02110004020202020204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370B692-781A-018A-5788-7D5B16A65AE8}"/>
              </a:ext>
            </a:extLst>
          </p:cNvPr>
          <p:cNvSpPr txBox="1"/>
          <p:nvPr/>
        </p:nvSpPr>
        <p:spPr>
          <a:xfrm>
            <a:off x="2357958" y="3885965"/>
            <a:ext cx="260385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defTabSz="342900"/>
            <a:r>
              <a:rPr lang="en-US" sz="1350">
                <a:solidFill>
                  <a:prstClr val="black"/>
                </a:solidFill>
                <a:latin typeface="Aptos" panose="02110004020202020204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FD2633-8540-AA96-0F6D-9E6DEB518A34}"/>
              </a:ext>
            </a:extLst>
          </p:cNvPr>
          <p:cNvSpPr txBox="1"/>
          <p:nvPr/>
        </p:nvSpPr>
        <p:spPr>
          <a:xfrm>
            <a:off x="3879545" y="133898"/>
            <a:ext cx="1842492" cy="223138"/>
          </a:xfrm>
          <a:prstGeom prst="rect">
            <a:avLst/>
          </a:prstGeom>
          <a:noFill/>
        </p:spPr>
        <p:txBody>
          <a:bodyPr wrap="none" lIns="68580" tIns="34290" rIns="68580" bIns="34290" rtlCol="0" anchor="t">
            <a:spAutoFit/>
          </a:bodyPr>
          <a:lstStyle/>
          <a:p>
            <a:pPr defTabSz="342900"/>
            <a:r>
              <a:rPr lang="en-US" sz="1000" b="1">
                <a:solidFill>
                  <a:prstClr val="black"/>
                </a:solidFill>
                <a:latin typeface="Aptos" panose="02110004020202020204"/>
              </a:rPr>
              <a:t>Figure S4: Natural Killer Cells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7FF7A0DD-17CC-76CB-2778-748F91F4E8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28925" y="4024464"/>
            <a:ext cx="3267075" cy="2476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843283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BFA1E88-5715-5911-A752-BEE61DC11C8A}"/>
              </a:ext>
            </a:extLst>
          </p:cNvPr>
          <p:cNvGraphicFramePr>
            <a:graphicFrameLocks noGrp="1"/>
          </p:cNvGraphicFramePr>
          <p:nvPr/>
        </p:nvGraphicFramePr>
        <p:xfrm>
          <a:off x="857250" y="508402"/>
          <a:ext cx="10368690" cy="5912063"/>
        </p:xfrm>
        <a:graphic>
          <a:graphicData uri="http://schemas.openxmlformats.org/drawingml/2006/table">
            <a:tbl>
              <a:tblPr/>
              <a:tblGrid>
                <a:gridCol w="691246">
                  <a:extLst>
                    <a:ext uri="{9D8B030D-6E8A-4147-A177-3AD203B41FA5}">
                      <a16:colId xmlns:a16="http://schemas.microsoft.com/office/drawing/2014/main" val="52409141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3488838538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86606549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73583822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2894346910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825044711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2432351160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3255633403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551346231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3384903898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1099006588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2102290942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2912518787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2657451825"/>
                    </a:ext>
                  </a:extLst>
                </a:gridCol>
                <a:gridCol w="691246">
                  <a:extLst>
                    <a:ext uri="{9D8B030D-6E8A-4147-A177-3AD203B41FA5}">
                      <a16:colId xmlns:a16="http://schemas.microsoft.com/office/drawing/2014/main" val="1181362574"/>
                    </a:ext>
                  </a:extLst>
                </a:gridCol>
              </a:tblGrid>
              <a:tr h="166588">
                <a:tc gridSpan="15"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Table S1: Patient Demographics, Baseline Disease Characteristics, and Outcome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399" marR="6399" marT="63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6335530"/>
                  </a:ext>
                </a:extLst>
              </a:tr>
              <a:tr h="63043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articipant ID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ge (yr)/sex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c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thnicity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isease Duration (yrs)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rior Therapies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GA week 2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hange in LPPAI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hange in DLQI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hange in skindex-16 scor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Change in </a:t>
                      </a:r>
                      <a:r>
                        <a:rPr lang="en-US" sz="1000" b="1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pruritis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NRS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Change in pruritus VAS: 24 </a:t>
                      </a:r>
                      <a:r>
                        <a:rPr lang="en-US" sz="1000" b="1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r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avg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Change in </a:t>
                      </a:r>
                      <a:r>
                        <a:rPr lang="de-DE" sz="1000" b="1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pruritus</a:t>
                      </a:r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VAS: 24 </a:t>
                      </a:r>
                      <a:r>
                        <a:rPr lang="de-DE" sz="1000" b="1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r</a:t>
                      </a:r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</a:t>
                      </a:r>
                      <a:r>
                        <a:rPr lang="de-DE" sz="1000" b="1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max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ime to response PGA (</a:t>
                      </a:r>
                      <a:r>
                        <a:rPr lang="en-US" sz="1000" b="1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wk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)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ime to response LPPAI (</a:t>
                      </a:r>
                      <a:r>
                        <a:rPr lang="en-US" sz="1000" b="1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wk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)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3044431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56-60/M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6.1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il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MTX, HCQ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.4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.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.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4117632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36-40/F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il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MTX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.7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5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4.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53599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56-60/M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6.5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il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MTX, HCQ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.7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.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5080508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56-60/F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6.8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MTX, HCQ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.6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5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6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4.9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5.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4741827"/>
                  </a:ext>
                </a:extLst>
              </a:tr>
              <a:tr h="63065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6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71-75/F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7.6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il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o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MTX, HCQ, MPA, 5-ARI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.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5.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5515948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46-50/F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.2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RUX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oABX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HCQ, BARI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4.1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4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.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.9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0727431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71-75/F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0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it-IT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MTX, 5-ARI, </a:t>
                      </a:r>
                      <a:r>
                        <a:rPr lang="it-IT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oCNI</a:t>
                      </a:r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ISO, PRP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.1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0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0.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0494148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71-75/M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AF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ilCCs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.4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0.8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0.9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6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6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0445047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61-65/F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6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oABX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D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D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D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D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D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D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D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/a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13095"/>
                  </a:ext>
                </a:extLst>
              </a:tr>
              <a:tr h="475968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61-65/F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hite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Not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hispani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 or Latino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t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</a:t>
                      </a:r>
                      <a:r>
                        <a:rPr lang="en-US" sz="1000" b="0" i="0" u="none" strike="noStrike" err="1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ilCCs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, MPA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.7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0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5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5.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.7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</a:t>
                      </a:r>
                    </a:p>
                  </a:txBody>
                  <a:tcPr marL="6399" marR="6399" marT="639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6807105"/>
                  </a:ext>
                </a:extLst>
              </a:tr>
              <a:tr h="200668">
                <a:tc gridSpan="15">
                  <a:txBody>
                    <a:bodyPr/>
                    <a:lstStyle/>
                    <a:p>
                      <a:pPr lvl="0" algn="l">
                        <a:buNone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ptos Narrow"/>
                        </a:rPr>
                        <a:t>*Age Range Reported to Limit Identifying Information</a:t>
                      </a:r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399" marR="6399" marT="6399" marB="0" anchor="b">
                    <a:lnL w="6350">
                      <a:solidFill>
                        <a:srgbClr val="000000"/>
                      </a:solidFill>
                    </a:lnL>
                    <a:lnR w="6350">
                      <a:solidFill>
                        <a:srgbClr val="000000"/>
                      </a:solidFill>
                    </a:lnR>
                    <a:lnT w="6350">
                      <a:solidFill>
                        <a:srgbClr val="000000"/>
                      </a:solidFill>
                    </a:lnT>
                    <a:lnB w="635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76241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860855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A8106F4-077D-27D2-79CB-BAC4314905EE}"/>
              </a:ext>
            </a:extLst>
          </p:cNvPr>
          <p:cNvGraphicFramePr>
            <a:graphicFrameLocks noGrp="1"/>
          </p:cNvGraphicFramePr>
          <p:nvPr/>
        </p:nvGraphicFramePr>
        <p:xfrm>
          <a:off x="3190681" y="1809750"/>
          <a:ext cx="5588001" cy="3238500"/>
        </p:xfrm>
        <a:graphic>
          <a:graphicData uri="http://schemas.openxmlformats.org/drawingml/2006/table">
            <a:tbl>
              <a:tblPr/>
              <a:tblGrid>
                <a:gridCol w="713969">
                  <a:extLst>
                    <a:ext uri="{9D8B030D-6E8A-4147-A177-3AD203B41FA5}">
                      <a16:colId xmlns:a16="http://schemas.microsoft.com/office/drawing/2014/main" val="1991530709"/>
                    </a:ext>
                  </a:extLst>
                </a:gridCol>
                <a:gridCol w="609254">
                  <a:extLst>
                    <a:ext uri="{9D8B030D-6E8A-4147-A177-3AD203B41FA5}">
                      <a16:colId xmlns:a16="http://schemas.microsoft.com/office/drawing/2014/main" val="585083748"/>
                    </a:ext>
                  </a:extLst>
                </a:gridCol>
                <a:gridCol w="609254">
                  <a:extLst>
                    <a:ext uri="{9D8B030D-6E8A-4147-A177-3AD203B41FA5}">
                      <a16:colId xmlns:a16="http://schemas.microsoft.com/office/drawing/2014/main" val="818620820"/>
                    </a:ext>
                  </a:extLst>
                </a:gridCol>
                <a:gridCol w="609254">
                  <a:extLst>
                    <a:ext uri="{9D8B030D-6E8A-4147-A177-3AD203B41FA5}">
                      <a16:colId xmlns:a16="http://schemas.microsoft.com/office/drawing/2014/main" val="1406167657"/>
                    </a:ext>
                  </a:extLst>
                </a:gridCol>
                <a:gridCol w="609254">
                  <a:extLst>
                    <a:ext uri="{9D8B030D-6E8A-4147-A177-3AD203B41FA5}">
                      <a16:colId xmlns:a16="http://schemas.microsoft.com/office/drawing/2014/main" val="270588547"/>
                    </a:ext>
                  </a:extLst>
                </a:gridCol>
                <a:gridCol w="609254">
                  <a:extLst>
                    <a:ext uri="{9D8B030D-6E8A-4147-A177-3AD203B41FA5}">
                      <a16:colId xmlns:a16="http://schemas.microsoft.com/office/drawing/2014/main" val="421990552"/>
                    </a:ext>
                  </a:extLst>
                </a:gridCol>
                <a:gridCol w="609254">
                  <a:extLst>
                    <a:ext uri="{9D8B030D-6E8A-4147-A177-3AD203B41FA5}">
                      <a16:colId xmlns:a16="http://schemas.microsoft.com/office/drawing/2014/main" val="231241863"/>
                    </a:ext>
                  </a:extLst>
                </a:gridCol>
                <a:gridCol w="609254">
                  <a:extLst>
                    <a:ext uri="{9D8B030D-6E8A-4147-A177-3AD203B41FA5}">
                      <a16:colId xmlns:a16="http://schemas.microsoft.com/office/drawing/2014/main" val="3617045597"/>
                    </a:ext>
                  </a:extLst>
                </a:gridCol>
                <a:gridCol w="609254">
                  <a:extLst>
                    <a:ext uri="{9D8B030D-6E8A-4147-A177-3AD203B41FA5}">
                      <a16:colId xmlns:a16="http://schemas.microsoft.com/office/drawing/2014/main" val="1353525556"/>
                    </a:ext>
                  </a:extLst>
                </a:gridCol>
              </a:tblGrid>
              <a:tr h="190500">
                <a:tc gridSpan="9"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Table S2: Physician Global Assessment (PGA) Scores by Week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15015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PGA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Week 2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Week 4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Week 8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Week 12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Week 16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Week 20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Week 24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Week 28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363054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n=10)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n=10)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n=10)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n=10)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n=10)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n=9)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n=9)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n=9)​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22011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Missing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1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74138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Grade 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1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39809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11.1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871573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Grade 1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20565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Grade 2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2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2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3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4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4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5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4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56186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2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2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3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44.4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44.4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55.6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44.4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52896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Grade 3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2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1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3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5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5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4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3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3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99308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2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1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3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5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55.6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44.4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33.3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33.3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93443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Grade 4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5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5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1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2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34243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5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5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1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2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257392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Grade 5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2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2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4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1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1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24009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2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2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4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11.1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11.1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70738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Grade 6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1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0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1 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8484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10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(11.1%)</a:t>
                      </a:r>
                      <a:r>
                        <a:rPr lang="en-US" sz="1000" b="0" i="0" u="none" strike="noStrike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</a:rPr>
                        <a:t>​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B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46912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211732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9683199-42F3-C4B3-3F39-F0D979808D0D}"/>
              </a:ext>
            </a:extLst>
          </p:cNvPr>
          <p:cNvGraphicFramePr>
            <a:graphicFrameLocks noGrp="1"/>
          </p:cNvGraphicFramePr>
          <p:nvPr/>
        </p:nvGraphicFramePr>
        <p:xfrm>
          <a:off x="4011050" y="409575"/>
          <a:ext cx="4169900" cy="5815754"/>
        </p:xfrm>
        <a:graphic>
          <a:graphicData uri="http://schemas.openxmlformats.org/drawingml/2006/table">
            <a:tbl>
              <a:tblPr/>
              <a:tblGrid>
                <a:gridCol w="833980">
                  <a:extLst>
                    <a:ext uri="{9D8B030D-6E8A-4147-A177-3AD203B41FA5}">
                      <a16:colId xmlns:a16="http://schemas.microsoft.com/office/drawing/2014/main" val="4127538137"/>
                    </a:ext>
                  </a:extLst>
                </a:gridCol>
                <a:gridCol w="833980">
                  <a:extLst>
                    <a:ext uri="{9D8B030D-6E8A-4147-A177-3AD203B41FA5}">
                      <a16:colId xmlns:a16="http://schemas.microsoft.com/office/drawing/2014/main" val="2396354009"/>
                    </a:ext>
                  </a:extLst>
                </a:gridCol>
                <a:gridCol w="833980">
                  <a:extLst>
                    <a:ext uri="{9D8B030D-6E8A-4147-A177-3AD203B41FA5}">
                      <a16:colId xmlns:a16="http://schemas.microsoft.com/office/drawing/2014/main" val="3925144447"/>
                    </a:ext>
                  </a:extLst>
                </a:gridCol>
                <a:gridCol w="833980">
                  <a:extLst>
                    <a:ext uri="{9D8B030D-6E8A-4147-A177-3AD203B41FA5}">
                      <a16:colId xmlns:a16="http://schemas.microsoft.com/office/drawing/2014/main" val="2641466790"/>
                    </a:ext>
                  </a:extLst>
                </a:gridCol>
                <a:gridCol w="833980">
                  <a:extLst>
                    <a:ext uri="{9D8B030D-6E8A-4147-A177-3AD203B41FA5}">
                      <a16:colId xmlns:a16="http://schemas.microsoft.com/office/drawing/2014/main" val="2935868917"/>
                    </a:ext>
                  </a:extLst>
                </a:gridCol>
              </a:tblGrid>
              <a:tr h="361576">
                <a:tc gridSpan="5"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Table S3 - Primary and Secondary Endpoints at Baseline and Week 24 (Per-Protocol Analysis)</a:t>
                      </a:r>
                    </a:p>
                  </a:txBody>
                  <a:tcPr marL="5181" marR="5181" marT="5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181" marR="5181" marT="5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181" marR="5181" marT="5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181" marR="5181" marT="5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6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5181" marR="5181" marT="51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7796570"/>
                  </a:ext>
                </a:extLst>
              </a:tr>
              <a:tr h="268117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aseline (n=9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eek 24 (n=9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ifference (n=9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 value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5237927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GA*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08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5302802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esponsive (n, %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11.1%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, 88.9%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799453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on-responsive (n, %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 (88.9%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, 11.1%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9452992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LPPAI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04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970468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.7 (1.2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2 (1.1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.5 (1.1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3140668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7-5.5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3 - 4.1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4.2-  -1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0767070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RS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175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3689290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.2 (2.4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.3 (1.9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.9 (3.3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1368450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7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7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6.0 - 5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318572"/>
                  </a:ext>
                </a:extLst>
              </a:tr>
              <a:tr h="14470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verage VRS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26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969219"/>
                  </a:ext>
                </a:extLst>
              </a:tr>
              <a:tr h="14470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3 (0.5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6 (0.5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0.8 (0.7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0069385"/>
                  </a:ext>
                </a:extLst>
              </a:tr>
              <a:tr h="14470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2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 - 1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 - 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1641708"/>
                  </a:ext>
                </a:extLst>
              </a:tr>
              <a:tr h="14470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Worst VRS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11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5011474"/>
                  </a:ext>
                </a:extLst>
              </a:tr>
              <a:tr h="14470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4 (0.5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7 (0.5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0.8 (0.4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5546137"/>
                  </a:ext>
                </a:extLst>
              </a:tr>
              <a:tr h="14470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2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 - 1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 - 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0400286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AS - Avg 24 hr itch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74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4289501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.8 (2.2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9 (1.9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.9 (3.1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6903548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6.6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2 - 6.1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5.2 - 4.7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2983017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AS - Max 24 hr itch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129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0662999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4.0 (2.6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.1 (2.0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.0 (3.3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3179190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7.5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1 - 6.3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5.8 - 5.1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2384200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kindex-16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2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9528556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5.6 (19.6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3.1 (8.8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22.4 (22.9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7748558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9.0 - 64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6.0 - 30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52.0 - 10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8595576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kindex Symptom Subscor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192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7961948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7.8 (6.0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.9 (2.5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.9 (7.6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3776023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16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9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4.0 - 8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9427573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kindex Emotional Subscor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2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3245147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2.6 (11.7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7.8 (5.9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4.8 (13.8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1325106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8.0 - 42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.0 - 19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6.0 - 6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2651033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kindex Functional Subscor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107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778902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5.2 (5.9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4 (3.0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3.8 (5.7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2025408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 - 15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0 - 8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3.0 - 3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4131711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LQI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.222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6089684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ean (SD)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3.9 (2.1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.8 (2.4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1.1 (2.5)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4745910"/>
                  </a:ext>
                </a:extLst>
              </a:tr>
              <a:tr h="134058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nge</a:t>
                      </a:r>
                    </a:p>
                  </a:txBody>
                  <a:tcPr marL="5181" marR="5181" marT="51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.0 - 8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.0 - 8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-7.0 - 1.0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5181" marR="5181" marT="518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7694505"/>
                  </a:ext>
                </a:extLst>
              </a:tr>
              <a:tr h="134058">
                <a:tc gridSpan="5"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*: For PGA, baseline was measured at week 2</a:t>
                      </a:r>
                    </a:p>
                  </a:txBody>
                  <a:tcPr marL="5181" marR="5181" marT="518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68195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686330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1D08544-7235-B173-19FB-E85EC8A06484}"/>
              </a:ext>
            </a:extLst>
          </p:cNvPr>
          <p:cNvGraphicFramePr>
            <a:graphicFrameLocks noGrp="1"/>
          </p:cNvGraphicFramePr>
          <p:nvPr/>
        </p:nvGraphicFramePr>
        <p:xfrm>
          <a:off x="3002076" y="1049225"/>
          <a:ext cx="6187848" cy="5216750"/>
        </p:xfrm>
        <a:graphic>
          <a:graphicData uri="http://schemas.openxmlformats.org/drawingml/2006/table">
            <a:tbl>
              <a:tblPr/>
              <a:tblGrid>
                <a:gridCol w="1546962">
                  <a:extLst>
                    <a:ext uri="{9D8B030D-6E8A-4147-A177-3AD203B41FA5}">
                      <a16:colId xmlns:a16="http://schemas.microsoft.com/office/drawing/2014/main" val="3996350238"/>
                    </a:ext>
                  </a:extLst>
                </a:gridCol>
                <a:gridCol w="1546962">
                  <a:extLst>
                    <a:ext uri="{9D8B030D-6E8A-4147-A177-3AD203B41FA5}">
                      <a16:colId xmlns:a16="http://schemas.microsoft.com/office/drawing/2014/main" val="1727042623"/>
                    </a:ext>
                  </a:extLst>
                </a:gridCol>
                <a:gridCol w="1546962">
                  <a:extLst>
                    <a:ext uri="{9D8B030D-6E8A-4147-A177-3AD203B41FA5}">
                      <a16:colId xmlns:a16="http://schemas.microsoft.com/office/drawing/2014/main" val="867747951"/>
                    </a:ext>
                  </a:extLst>
                </a:gridCol>
                <a:gridCol w="1546962">
                  <a:extLst>
                    <a:ext uri="{9D8B030D-6E8A-4147-A177-3AD203B41FA5}">
                      <a16:colId xmlns:a16="http://schemas.microsoft.com/office/drawing/2014/main" val="4191154265"/>
                    </a:ext>
                  </a:extLst>
                </a:gridCol>
              </a:tblGrid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Table S4: Adverse Events</a:t>
                      </a:r>
                    </a:p>
                  </a:txBody>
                  <a:tcPr marL="7502" marR="7502" marT="75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502" marR="7502" marT="75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502" marR="7502" marT="75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502" marR="7502" marT="750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338832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ossible/Probable/Definite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Unrelated/Unlikely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Number of Patients Affected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098910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dverse Event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(N=13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(N=18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 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348172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cne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9 (69.2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9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97178900"/>
                  </a:ext>
                </a:extLst>
              </a:tr>
              <a:tr h="30009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Admission to hospital for Colon and Rectal Surgery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311016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Bakers Cyst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2053798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anker Sore and Mouth Tenderness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5428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anker Sores on Tongue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22867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anker Sores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55206"/>
                  </a:ext>
                </a:extLst>
              </a:tr>
              <a:tr h="30009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Cold/URI/discharge from eyes/ almost went to ED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363599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Diverticulitis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777020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Fever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680328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GI pain after starting Protopic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18235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Hand Dermatitis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7.7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073846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Headache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2 (11.1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599030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Inflammation of Gingiva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605793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outh Burning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397328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Mouth pain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5013951"/>
                  </a:ext>
                </a:extLst>
              </a:tr>
              <a:tr h="30009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ain in right ear, like nerve pain, seems to pulse between ear and scalp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0135184"/>
                  </a:ext>
                </a:extLst>
              </a:tr>
              <a:tr h="300092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Presented to ED with abdominal pain related to diverticulitis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176254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sh around neck/ears/face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7.7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615551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sh on neck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090589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Rash/acne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7.7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216010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ore throat/lymph node area/sickness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5.6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328085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Virus (cold/flu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 (7.7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0 (0%)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1</a:t>
                      </a:r>
                    </a:p>
                  </a:txBody>
                  <a:tcPr marL="7502" marR="7502" marT="750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26633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595219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47137FD-76D4-3DC0-CCA4-8B4D09E34D80}"/>
              </a:ext>
            </a:extLst>
          </p:cNvPr>
          <p:cNvGraphicFramePr>
            <a:graphicFrameLocks noGrp="1"/>
          </p:cNvGraphicFramePr>
          <p:nvPr/>
        </p:nvGraphicFramePr>
        <p:xfrm>
          <a:off x="3966454" y="530086"/>
          <a:ext cx="4259091" cy="5797827"/>
        </p:xfrm>
        <a:graphic>
          <a:graphicData uri="http://schemas.openxmlformats.org/drawingml/2006/table">
            <a:tbl>
              <a:tblPr/>
              <a:tblGrid>
                <a:gridCol w="518395">
                  <a:extLst>
                    <a:ext uri="{9D8B030D-6E8A-4147-A177-3AD203B41FA5}">
                      <a16:colId xmlns:a16="http://schemas.microsoft.com/office/drawing/2014/main" val="2515440176"/>
                    </a:ext>
                  </a:extLst>
                </a:gridCol>
                <a:gridCol w="706903">
                  <a:extLst>
                    <a:ext uri="{9D8B030D-6E8A-4147-A177-3AD203B41FA5}">
                      <a16:colId xmlns:a16="http://schemas.microsoft.com/office/drawing/2014/main" val="1556274070"/>
                    </a:ext>
                  </a:extLst>
                </a:gridCol>
                <a:gridCol w="1068210">
                  <a:extLst>
                    <a:ext uri="{9D8B030D-6E8A-4147-A177-3AD203B41FA5}">
                      <a16:colId xmlns:a16="http://schemas.microsoft.com/office/drawing/2014/main" val="3729283133"/>
                    </a:ext>
                  </a:extLst>
                </a:gridCol>
                <a:gridCol w="604795">
                  <a:extLst>
                    <a:ext uri="{9D8B030D-6E8A-4147-A177-3AD203B41FA5}">
                      <a16:colId xmlns:a16="http://schemas.microsoft.com/office/drawing/2014/main" val="2278474179"/>
                    </a:ext>
                  </a:extLst>
                </a:gridCol>
                <a:gridCol w="824720">
                  <a:extLst>
                    <a:ext uri="{9D8B030D-6E8A-4147-A177-3AD203B41FA5}">
                      <a16:colId xmlns:a16="http://schemas.microsoft.com/office/drawing/2014/main" val="698733561"/>
                    </a:ext>
                  </a:extLst>
                </a:gridCol>
                <a:gridCol w="536068">
                  <a:extLst>
                    <a:ext uri="{9D8B030D-6E8A-4147-A177-3AD203B41FA5}">
                      <a16:colId xmlns:a16="http://schemas.microsoft.com/office/drawing/2014/main" val="1286964633"/>
                    </a:ext>
                  </a:extLst>
                </a:gridCol>
              </a:tblGrid>
              <a:tr h="110570">
                <a:tc gridSpan="6"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</a:rPr>
                        <a:t>Table S5: Patient Level Adverse Events</a:t>
                      </a:r>
                    </a:p>
                  </a:txBody>
                  <a:tcPr marL="4819" marR="4819" marT="481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8588651"/>
                  </a:ext>
                </a:extLst>
              </a:tr>
              <a:tr h="30406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Participant I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dverse Event Term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dverse Event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Is the adverse event serious?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Severity/Grade 1 - 3 CTCAE version 3.0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ttribution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0341100"/>
                  </a:ext>
                </a:extLst>
              </a:tr>
              <a:tr h="80377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4755564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iverticuliti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odera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relate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7279612"/>
                  </a:ext>
                </a:extLst>
              </a:tr>
              <a:tr h="33170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Presented to ED with abdominal pain related to Diverticuliti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Ye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Sever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5377096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Virus (cold/flu)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Probabl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9080981"/>
                  </a:ext>
                </a:extLst>
              </a:tr>
              <a:tr h="243253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dmission to hospital for Colon and Rectal surger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Ye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Sever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9288963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2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0329998"/>
                  </a:ext>
                </a:extLst>
              </a:tr>
              <a:tr h="22113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2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GI pain after starting Protopic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odera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related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9397428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2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Canker sore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5475633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2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Inflammation of Gingiva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relate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7395734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3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Rash/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1028752"/>
                  </a:ext>
                </a:extLst>
              </a:tr>
              <a:tr h="22113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3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Rash around neck/ears/fac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Possibl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2341964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3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Fev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044783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3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outh burning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relate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487388"/>
                  </a:ext>
                </a:extLst>
              </a:tr>
              <a:tr h="22113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3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Sore throat/lymphnode area/sicknes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relate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5778113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5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8896381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5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Rash on neck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relate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4540638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6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896814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6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Headach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4631098"/>
                  </a:ext>
                </a:extLst>
              </a:tr>
              <a:tr h="22113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6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Canker Sore and Mouth Tendernes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9385730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6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outh pain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2554020"/>
                  </a:ext>
                </a:extLst>
              </a:tr>
              <a:tr h="353823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6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Pain in right ear, like nerve pain, seems to pulse between ear and scalp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8324892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6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Canker Sore on Tongu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0417217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6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Headach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relate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5512195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1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9784262"/>
                  </a:ext>
                </a:extLst>
              </a:tr>
              <a:tr h="221139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2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Cold/URI/discharge from eyes, almost went to 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odera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likely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0655606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2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Probabl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3122373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3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0087802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4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4274402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5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Acn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 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Defini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2017793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5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Bakers Cyst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oderat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Unrelate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0714673"/>
                  </a:ext>
                </a:extLst>
              </a:tr>
              <a:tr h="11057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15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Other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Hand Dermatitis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No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Mild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ptos Display" panose="020B0004020202020204" pitchFamily="34" charset="0"/>
                        </a:rPr>
                        <a:t>Possible</a:t>
                      </a:r>
                    </a:p>
                  </a:txBody>
                  <a:tcPr marL="4819" marR="4819" marT="481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43107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24948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227B95DCAA51047968EC6F8FCB21742" ma:contentTypeVersion="18" ma:contentTypeDescription="Create a new document." ma:contentTypeScope="" ma:versionID="9a217fa05641a057515a6d23eda0cf3b">
  <xsd:schema xmlns:xsd="http://www.w3.org/2001/XMLSchema" xmlns:xs="http://www.w3.org/2001/XMLSchema" xmlns:p="http://schemas.microsoft.com/office/2006/metadata/properties" xmlns:ns2="bc1199f8-0a19-4c52-a5ef-858eb76648f7" xmlns:ns3="7faa3a00-8edb-4352-9dd1-cde9699bd6b4" targetNamespace="http://schemas.microsoft.com/office/2006/metadata/properties" ma:root="true" ma:fieldsID="c365c25fe396b6958ea903c8e8f6b7c7" ns2:_="" ns3:_="">
    <xsd:import namespace="bc1199f8-0a19-4c52-a5ef-858eb76648f7"/>
    <xsd:import namespace="7faa3a00-8edb-4352-9dd1-cde9699bd6b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lcf76f155ced4ddcb4097134ff3c332f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  <xsd:element ref="ns2:MediaServiceBillingMetadata" minOccurs="0"/>
                <xsd:element ref="ns2:MediaLengthInSeconds" minOccurs="0"/>
                <xsd:element ref="ns2:Comme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c1199f8-0a19-4c52-a5ef-858eb76648f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7c5d3906-26d2-4840-9c74-966ccfe297a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BillingMetadata" ma:index="21" nillable="true" ma:displayName="MediaServiceBillingMetadata" ma:hidden="true" ma:internalName="MediaServiceBillingMetadata" ma:readOnly="true">
      <xsd:simpleType>
        <xsd:restriction base="dms:Note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Comments" ma:index="23" nillable="true" ma:displayName="Comments" ma:format="Dropdown" ma:internalName="Comments">
      <xsd:simpleType>
        <xsd:restriction base="dms:Text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faa3a00-8edb-4352-9dd1-cde9699bd6b4" elementFormDefault="qualified">
    <xsd:import namespace="http://schemas.microsoft.com/office/2006/documentManagement/types"/>
    <xsd:import namespace="http://schemas.microsoft.com/office/infopath/2007/PartnerControls"/>
    <xsd:element name="TaxCatchAll" ma:index="10" nillable="true" ma:displayName="Taxonomy Catch All Column" ma:hidden="true" ma:list="{a3634bdf-b003-4d14-9556-1ee6c828ce59}" ma:internalName="TaxCatchAll" ma:showField="CatchAllData" ma:web="7faa3a00-8edb-4352-9dd1-cde9699bd6b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c1199f8-0a19-4c52-a5ef-858eb76648f7">
      <Terms xmlns="http://schemas.microsoft.com/office/infopath/2007/PartnerControls"/>
    </lcf76f155ced4ddcb4097134ff3c332f>
    <TaxCatchAll xmlns="7faa3a00-8edb-4352-9dd1-cde9699bd6b4" xsi:nil="true"/>
    <Comments xmlns="bc1199f8-0a19-4c52-a5ef-858eb76648f7" xsi:nil="true"/>
  </documentManagement>
</p:properties>
</file>

<file path=customXml/itemProps1.xml><?xml version="1.0" encoding="utf-8"?>
<ds:datastoreItem xmlns:ds="http://schemas.openxmlformats.org/officeDocument/2006/customXml" ds:itemID="{DC280C02-2269-4E9C-A3D5-CB4518CB70B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7A2888E-B4AD-4E3F-9080-F1EC08B6BCF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c1199f8-0a19-4c52-a5ef-858eb76648f7"/>
    <ds:schemaRef ds:uri="7faa3a00-8edb-4352-9dd1-cde9699bd6b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11E7BE9D-66DF-45F7-8D76-FF3404DD7A53}">
  <ds:schemaRefs>
    <ds:schemaRef ds:uri="http://schemas.microsoft.com/office/2006/metadata/properties"/>
    <ds:schemaRef ds:uri="http://schemas.microsoft.com/office/infopath/2007/PartnerControls"/>
    <ds:schemaRef ds:uri="bc1199f8-0a19-4c52-a5ef-858eb76648f7"/>
    <ds:schemaRef ds:uri="7faa3a00-8edb-4352-9dd1-cde9699bd6b4"/>
  </ds:schemaRefs>
</ds:datastoreItem>
</file>

<file path=docMetadata/LabelInfo.xml><?xml version="1.0" encoding="utf-8"?>
<clbl:labelList xmlns:clbl="http://schemas.microsoft.com/office/2020/mipLabelMetadata">
  <clbl:label id="{990794cc-8ced-4156-9787-a1fbf819c752}" enabled="1" method="Standard" siteId="{a25fff9c-3f63-4fb2-9a8a-d9bdd0321f9a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0</Words>
  <Application>Microsoft Office PowerPoint</Application>
  <PresentationFormat>Widescreen</PresentationFormat>
  <Paragraphs>0</Paragraphs>
  <Slides>9</Slides>
  <Notes>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5</cp:revision>
  <dcterms:created xsi:type="dcterms:W3CDTF">2026-03-13T21:52:19Z</dcterms:created>
  <dcterms:modified xsi:type="dcterms:W3CDTF">2026-03-13T21:54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227B95DCAA51047968EC6F8FCB21742</vt:lpwstr>
  </property>
  <property fmtid="{D5CDD505-2E9C-101B-9397-08002B2CF9AE}" pid="3" name="MediaServiceImageTags">
    <vt:lpwstr/>
  </property>
</Properties>
</file>